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25D010-50BD-4ED9-9520-A6CD710C2FA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A43DE9-55CD-475A-9E60-10A3125CA1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A697B8-7F2A-4F9C-BD05-3968E51748C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96B365-8C59-4947-B21D-2882A9502A5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625A75-51AE-43D6-9303-79CD668B63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B16F9A-9998-4EED-A4CE-7CBA5FA8B99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85299B-C45E-4A64-AB8C-81E0E7DD84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C440FB-26CB-4C92-97DC-3B8CB78D86B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92468F-6AC1-4AF3-90B5-D682BA509E8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C60967-5FCB-461E-9181-A0B00958BC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A4B7CD-937F-4854-A79F-94EC164EA8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A535FF-8228-4D46-8715-B2D44AB773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EBB336B-9131-4AFE-BFDB-6B6F0B1C5775}" type="datetime"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4ECD752-30F8-4EC3-A81B-4B9B8CD4B8DC}" type="slidenum"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62" descr="M:\PhD M.Leite\AnxA1\Article and Presentations\KM curves for article\Doxo high m50 DMFS.tif"/>
          <p:cNvPicPr/>
          <p:nvPr/>
        </p:nvPicPr>
        <p:blipFill>
          <a:blip r:embed="rId1"/>
          <a:srcRect l="11785" t="5947" r="3048" b="16826"/>
          <a:stretch/>
        </p:blipFill>
        <p:spPr>
          <a:xfrm>
            <a:off x="4462560" y="1692360"/>
            <a:ext cx="2031840" cy="133992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63" descr="M:\PhD M.Leite\AnxA1\Article and Presentations\KM curves for article\Doxo high m50 DMFS.tif"/>
          <p:cNvPicPr/>
          <p:nvPr/>
        </p:nvPicPr>
        <p:blipFill>
          <a:blip r:embed="rId2"/>
          <a:srcRect l="10789" t="4206" r="2761" b="16494"/>
          <a:stretch/>
        </p:blipFill>
        <p:spPr>
          <a:xfrm>
            <a:off x="4443480" y="3262320"/>
            <a:ext cx="2062080" cy="137628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64" descr="M:\PhD M.Leite\AnxA1\Article and Presentations\KM curves for article\HIgh Risk 50.69 .all DMFS.tif"/>
          <p:cNvPicPr/>
          <p:nvPr/>
        </p:nvPicPr>
        <p:blipFill>
          <a:blip r:embed="rId3"/>
          <a:srcRect l="12193" t="5636" r="2746" b="16017"/>
          <a:stretch/>
        </p:blipFill>
        <p:spPr>
          <a:xfrm>
            <a:off x="4451400" y="4797360"/>
            <a:ext cx="2028600" cy="1359000"/>
          </a:xfrm>
          <a:prstGeom prst="rect">
            <a:avLst/>
          </a:prstGeom>
          <a:ln w="0">
            <a:noFill/>
          </a:ln>
        </p:spPr>
      </p:pic>
      <p:grpSp>
        <p:nvGrpSpPr>
          <p:cNvPr id="44" name="Group 4"/>
          <p:cNvGrpSpPr/>
          <p:nvPr/>
        </p:nvGrpSpPr>
        <p:grpSpPr>
          <a:xfrm>
            <a:off x="2368440" y="4807080"/>
            <a:ext cx="2052720" cy="1331640"/>
            <a:chOff x="2368440" y="4807080"/>
            <a:chExt cx="2052720" cy="1331640"/>
          </a:xfrm>
        </p:grpSpPr>
        <p:pic>
          <p:nvPicPr>
            <p:cNvPr id="45" name="Picture 59" descr="M:\PhD M.Leite\AnxA1\Article and Presentations\KM curves for article\Chemo high 50-69 BCSS.tif"/>
            <p:cNvPicPr/>
            <p:nvPr/>
          </p:nvPicPr>
          <p:blipFill>
            <a:blip r:embed="rId4"/>
            <a:srcRect l="11272" t="6258" r="2671" b="17033"/>
            <a:stretch/>
          </p:blipFill>
          <p:spPr>
            <a:xfrm>
              <a:off x="2368440" y="4807080"/>
              <a:ext cx="2052720" cy="1331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Rectangle 65"/>
            <p:cNvSpPr/>
            <p:nvPr/>
          </p:nvSpPr>
          <p:spPr>
            <a:xfrm>
              <a:off x="3414600" y="5668920"/>
              <a:ext cx="320400" cy="21564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7" name="Group 3"/>
          <p:cNvGrpSpPr/>
          <p:nvPr/>
        </p:nvGrpSpPr>
        <p:grpSpPr>
          <a:xfrm>
            <a:off x="252360" y="4788000"/>
            <a:ext cx="2057400" cy="1371600"/>
            <a:chOff x="252360" y="4788000"/>
            <a:chExt cx="2057400" cy="1371600"/>
          </a:xfrm>
        </p:grpSpPr>
        <p:pic>
          <p:nvPicPr>
            <p:cNvPr id="48" name="Picture 60" descr="M:\PhD M.Leite\AnxA1\Article and Presentations\KM curves for article\Chemo high 50-69 OS.tif"/>
            <p:cNvPicPr/>
            <p:nvPr/>
          </p:nvPicPr>
          <p:blipFill>
            <a:blip r:embed="rId5"/>
            <a:srcRect l="11091" t="5035" r="2641" b="15935"/>
            <a:stretch/>
          </p:blipFill>
          <p:spPr>
            <a:xfrm>
              <a:off x="252360" y="4788000"/>
              <a:ext cx="2057400" cy="1371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Rectangle 2"/>
            <p:cNvSpPr/>
            <p:nvPr/>
          </p:nvSpPr>
          <p:spPr>
            <a:xfrm>
              <a:off x="1270080" y="5673960"/>
              <a:ext cx="322200" cy="21564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50" name="Picture 56" descr="M:\PhD M.Leite\AnxA1\Article and Presentations\KM curves for article\Chemo high m50 BCSS.tif"/>
          <p:cNvPicPr/>
          <p:nvPr/>
        </p:nvPicPr>
        <p:blipFill>
          <a:blip r:embed="rId6"/>
          <a:srcRect l="11710" t="5988" r="2746" b="15789"/>
          <a:stretch/>
        </p:blipFill>
        <p:spPr>
          <a:xfrm>
            <a:off x="2349360" y="3297240"/>
            <a:ext cx="2040120" cy="135900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57" descr="M:\PhD M.Leite\AnxA1\Article and Presentations\KM curves for article\Chemo high m50 OS.tif"/>
          <p:cNvPicPr/>
          <p:nvPr/>
        </p:nvPicPr>
        <p:blipFill>
          <a:blip r:embed="rId7"/>
          <a:srcRect l="10638" t="5988" r="3425" b="15789"/>
          <a:stretch/>
        </p:blipFill>
        <p:spPr>
          <a:xfrm>
            <a:off x="260280" y="3297240"/>
            <a:ext cx="2049480" cy="135900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54" descr="M:\PhD M.Leite\AnxA1\Article and Presentations\KM curves for article\Chemo low all OS.tif"/>
          <p:cNvPicPr/>
          <p:nvPr/>
        </p:nvPicPr>
        <p:blipFill>
          <a:blip r:embed="rId8"/>
          <a:srcRect l="11785" t="7232" r="2550" b="16577"/>
          <a:stretch/>
        </p:blipFill>
        <p:spPr>
          <a:xfrm>
            <a:off x="252360" y="1725480"/>
            <a:ext cx="2043000" cy="132264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51" descr="M:\PhD M.Leite\AnxA1\Article and Presentations\KM curves for article\Chemo low all BCSS.tif"/>
          <p:cNvPicPr/>
          <p:nvPr/>
        </p:nvPicPr>
        <p:blipFill>
          <a:blip r:embed="rId9"/>
          <a:srcRect l="12042" t="6444" r="3154" b="16722"/>
          <a:stretch/>
        </p:blipFill>
        <p:spPr>
          <a:xfrm>
            <a:off x="2305080" y="1720800"/>
            <a:ext cx="2022480" cy="1333440"/>
          </a:xfrm>
          <a:prstGeom prst="rect">
            <a:avLst/>
          </a:prstGeom>
          <a:ln w="0">
            <a:noFill/>
          </a:ln>
        </p:spPr>
      </p:pic>
      <p:sp>
        <p:nvSpPr>
          <p:cNvPr id="54" name="TextBox 14"/>
          <p:cNvSpPr/>
          <p:nvPr/>
        </p:nvSpPr>
        <p:spPr>
          <a:xfrm>
            <a:off x="527040" y="5378400"/>
            <a:ext cx="1079640" cy="28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R = 2.10 (1.32 – 3.34)</a:t>
            </a:r>
            <a:br>
              <a:rPr sz="600"/>
            </a:b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R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adj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 1.63 (0.97 – 2.74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14"/>
          <p:cNvSpPr/>
          <p:nvPr/>
        </p:nvSpPr>
        <p:spPr>
          <a:xfrm>
            <a:off x="2633760" y="5376960"/>
            <a:ext cx="1079280" cy="28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R = 2.02 (1.21 – 3.36)</a:t>
            </a:r>
            <a:br>
              <a:rPr sz="600"/>
            </a:b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R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adj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 1.41 (0.80 – 2.5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19"/>
          <p:cNvSpPr/>
          <p:nvPr/>
        </p:nvSpPr>
        <p:spPr>
          <a:xfrm>
            <a:off x="333360" y="6221520"/>
            <a:ext cx="6191280" cy="145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5: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rvival curves and hazard ratios crude (HR) and adjusted (HR</a:t>
            </a:r>
            <a:r>
              <a:rPr b="0" lang="en-US" sz="11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adj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according to ANXA1 expression in patients eligible for adjuvant chemotherapy in the BCAC.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verall Survival, Breast cancer Specific Survival and Distant Metastasis Free Survival in patients with low risk of recurrence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, B, C)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patients under 50 years-old with high risk of recurrence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D, E, F)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and patients over 49 and under 70 years-old with high risk of recurrence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G, H, I)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Hazard ratios adjusted by: age of diagnosis, tumor grade, tumor size, lymph node metastasis, ER/PR status and HER2 status. Note: Low risk of recurrence: 35 years old or younger, lymph node negative, and tumor size ≥ 2cm or tumor size ≥ 1cm and tumor grade ≥ 2; high risk of recurrence: HER2+ and/or lymph node positive. 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6"/>
          <p:cNvSpPr/>
          <p:nvPr/>
        </p:nvSpPr>
        <p:spPr>
          <a:xfrm>
            <a:off x="168120" y="1547640"/>
            <a:ext cx="28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7"/>
          <p:cNvSpPr/>
          <p:nvPr/>
        </p:nvSpPr>
        <p:spPr>
          <a:xfrm>
            <a:off x="2230560" y="1554120"/>
            <a:ext cx="285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8"/>
          <p:cNvSpPr/>
          <p:nvPr/>
        </p:nvSpPr>
        <p:spPr>
          <a:xfrm>
            <a:off x="4381560" y="1550880"/>
            <a:ext cx="28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11"/>
          <p:cNvSpPr/>
          <p:nvPr/>
        </p:nvSpPr>
        <p:spPr>
          <a:xfrm>
            <a:off x="168120" y="3033720"/>
            <a:ext cx="28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12"/>
          <p:cNvSpPr/>
          <p:nvPr/>
        </p:nvSpPr>
        <p:spPr>
          <a:xfrm>
            <a:off x="2232000" y="3043080"/>
            <a:ext cx="28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13"/>
          <p:cNvSpPr/>
          <p:nvPr/>
        </p:nvSpPr>
        <p:spPr>
          <a:xfrm>
            <a:off x="4381560" y="3036960"/>
            <a:ext cx="28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14"/>
          <p:cNvSpPr/>
          <p:nvPr/>
        </p:nvSpPr>
        <p:spPr>
          <a:xfrm>
            <a:off x="173160" y="4643280"/>
            <a:ext cx="285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15"/>
          <p:cNvSpPr/>
          <p:nvPr/>
        </p:nvSpPr>
        <p:spPr>
          <a:xfrm>
            <a:off x="2236680" y="4653000"/>
            <a:ext cx="28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16"/>
          <p:cNvSpPr/>
          <p:nvPr/>
        </p:nvSpPr>
        <p:spPr>
          <a:xfrm>
            <a:off x="4386240" y="4649760"/>
            <a:ext cx="28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7"/>
          <p:cNvSpPr/>
          <p:nvPr/>
        </p:nvSpPr>
        <p:spPr>
          <a:xfrm>
            <a:off x="476280" y="1582560"/>
            <a:ext cx="18241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w risk of recurrence (all ages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7"/>
          <p:cNvSpPr/>
          <p:nvPr/>
        </p:nvSpPr>
        <p:spPr>
          <a:xfrm>
            <a:off x="428760" y="3071880"/>
            <a:ext cx="18237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igh risk of recurrence (&lt; 50 years-old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7"/>
          <p:cNvSpPr/>
          <p:nvPr/>
        </p:nvSpPr>
        <p:spPr>
          <a:xfrm>
            <a:off x="428760" y="4681440"/>
            <a:ext cx="18237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igh risk of recurrence (50-69 years-old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7"/>
          <p:cNvSpPr/>
          <p:nvPr/>
        </p:nvSpPr>
        <p:spPr>
          <a:xfrm>
            <a:off x="2635200" y="1585800"/>
            <a:ext cx="18241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w risk of recurrence (all ages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7"/>
          <p:cNvSpPr/>
          <p:nvPr/>
        </p:nvSpPr>
        <p:spPr>
          <a:xfrm>
            <a:off x="2587680" y="3078000"/>
            <a:ext cx="18241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igh risk of recurrence (&lt; 50 years-old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7"/>
          <p:cNvSpPr/>
          <p:nvPr/>
        </p:nvSpPr>
        <p:spPr>
          <a:xfrm>
            <a:off x="2587680" y="4684680"/>
            <a:ext cx="18241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igh risk of recurrence (50-69 years-old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7"/>
          <p:cNvSpPr/>
          <p:nvPr/>
        </p:nvSpPr>
        <p:spPr>
          <a:xfrm>
            <a:off x="4724280" y="1592280"/>
            <a:ext cx="18241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w risk of recurrence (all ages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7"/>
          <p:cNvSpPr/>
          <p:nvPr/>
        </p:nvSpPr>
        <p:spPr>
          <a:xfrm>
            <a:off x="4676760" y="3081240"/>
            <a:ext cx="18241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igh risk of recurrence (&lt; 50 years-old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7"/>
          <p:cNvSpPr/>
          <p:nvPr/>
        </p:nvSpPr>
        <p:spPr>
          <a:xfrm>
            <a:off x="4676760" y="4691160"/>
            <a:ext cx="18241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igh risk of recurrence (50-69 years-old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Straight Connector 33"/>
          <p:cNvSpPr/>
          <p:nvPr/>
        </p:nvSpPr>
        <p:spPr>
          <a:xfrm>
            <a:off x="635040" y="5389560"/>
            <a:ext cx="7207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Box 14"/>
          <p:cNvSpPr/>
          <p:nvPr/>
        </p:nvSpPr>
        <p:spPr>
          <a:xfrm>
            <a:off x="539640" y="5235480"/>
            <a:ext cx="647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 years survival: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Straight Connector 35"/>
          <p:cNvSpPr/>
          <p:nvPr/>
        </p:nvSpPr>
        <p:spPr>
          <a:xfrm>
            <a:off x="2728800" y="5375160"/>
            <a:ext cx="7207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Box 14"/>
          <p:cNvSpPr/>
          <p:nvPr/>
        </p:nvSpPr>
        <p:spPr>
          <a:xfrm>
            <a:off x="2633760" y="5219640"/>
            <a:ext cx="647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 years survival: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43"/>
          <p:cNvSpPr/>
          <p:nvPr/>
        </p:nvSpPr>
        <p:spPr>
          <a:xfrm>
            <a:off x="3357720" y="2635200"/>
            <a:ext cx="287280" cy="144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Box 14"/>
          <p:cNvSpPr/>
          <p:nvPr/>
        </p:nvSpPr>
        <p:spPr>
          <a:xfrm>
            <a:off x="5415120" y="2549520"/>
            <a:ext cx="50292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 = 17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 = 3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Box 14"/>
          <p:cNvSpPr/>
          <p:nvPr/>
        </p:nvSpPr>
        <p:spPr>
          <a:xfrm>
            <a:off x="3286080" y="2562120"/>
            <a:ext cx="50328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 = 29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 = 10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Box 14"/>
          <p:cNvSpPr/>
          <p:nvPr/>
        </p:nvSpPr>
        <p:spPr>
          <a:xfrm>
            <a:off x="5446800" y="5665680"/>
            <a:ext cx="50328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 = 17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 = 6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Box 14"/>
          <p:cNvSpPr/>
          <p:nvPr/>
        </p:nvSpPr>
        <p:spPr>
          <a:xfrm>
            <a:off x="3308400" y="5665680"/>
            <a:ext cx="50328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 = 41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 = 6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14"/>
          <p:cNvSpPr/>
          <p:nvPr/>
        </p:nvSpPr>
        <p:spPr>
          <a:xfrm>
            <a:off x="1241280" y="5661000"/>
            <a:ext cx="50328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 = 41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 = 6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14"/>
          <p:cNvSpPr/>
          <p:nvPr/>
        </p:nvSpPr>
        <p:spPr>
          <a:xfrm>
            <a:off x="4718160" y="5383080"/>
            <a:ext cx="1079280" cy="28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R = 2.64 (1.23 – 5.66)</a:t>
            </a:r>
            <a:br>
              <a:rPr sz="600"/>
            </a:b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R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adj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 1.33 (0.46 – 3.82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Straight Connector 53"/>
          <p:cNvSpPr/>
          <p:nvPr/>
        </p:nvSpPr>
        <p:spPr>
          <a:xfrm>
            <a:off x="4826160" y="5394240"/>
            <a:ext cx="7189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Box 14"/>
          <p:cNvSpPr/>
          <p:nvPr/>
        </p:nvSpPr>
        <p:spPr>
          <a:xfrm>
            <a:off x="4729320" y="5238720"/>
            <a:ext cx="6490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 years survival: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56"/>
          <p:cNvSpPr/>
          <p:nvPr/>
        </p:nvSpPr>
        <p:spPr>
          <a:xfrm>
            <a:off x="5565600" y="4237200"/>
            <a:ext cx="287640" cy="144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58"/>
          <p:cNvSpPr/>
          <p:nvPr/>
        </p:nvSpPr>
        <p:spPr>
          <a:xfrm>
            <a:off x="3392640" y="4179960"/>
            <a:ext cx="287280" cy="195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14"/>
          <p:cNvSpPr/>
          <p:nvPr/>
        </p:nvSpPr>
        <p:spPr>
          <a:xfrm>
            <a:off x="3314880" y="4154400"/>
            <a:ext cx="50292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 = 80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 = 10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60"/>
          <p:cNvSpPr/>
          <p:nvPr/>
        </p:nvSpPr>
        <p:spPr>
          <a:xfrm>
            <a:off x="5545080" y="4135320"/>
            <a:ext cx="39996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61"/>
          <p:cNvSpPr/>
          <p:nvPr/>
        </p:nvSpPr>
        <p:spPr>
          <a:xfrm>
            <a:off x="1322280" y="4226040"/>
            <a:ext cx="287280" cy="144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14"/>
          <p:cNvSpPr/>
          <p:nvPr/>
        </p:nvSpPr>
        <p:spPr>
          <a:xfrm>
            <a:off x="5478480" y="4159080"/>
            <a:ext cx="50328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 = 23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 = 7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14"/>
          <p:cNvSpPr/>
          <p:nvPr/>
        </p:nvSpPr>
        <p:spPr>
          <a:xfrm>
            <a:off x="1244520" y="4152960"/>
            <a:ext cx="50328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 = 80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 = 10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55"/>
          <p:cNvSpPr/>
          <p:nvPr/>
        </p:nvSpPr>
        <p:spPr>
          <a:xfrm>
            <a:off x="795240" y="2624040"/>
            <a:ext cx="193680" cy="149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Box 14"/>
          <p:cNvSpPr/>
          <p:nvPr/>
        </p:nvSpPr>
        <p:spPr>
          <a:xfrm>
            <a:off x="717480" y="2556000"/>
            <a:ext cx="504720" cy="27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ANXA1</a:t>
            </a:r>
            <a:br>
              <a:rPr sz="400"/>
            </a:br>
            <a:r>
              <a:rPr b="1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ANXA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59"/>
          <p:cNvSpPr/>
          <p:nvPr/>
        </p:nvSpPr>
        <p:spPr>
          <a:xfrm>
            <a:off x="2852640" y="2637000"/>
            <a:ext cx="193680" cy="149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Box 14"/>
          <p:cNvSpPr/>
          <p:nvPr/>
        </p:nvSpPr>
        <p:spPr>
          <a:xfrm>
            <a:off x="2774880" y="2568600"/>
            <a:ext cx="503280" cy="27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ANXA1</a:t>
            </a:r>
            <a:br>
              <a:rPr sz="400"/>
            </a:br>
            <a:r>
              <a:rPr b="1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ANXA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63"/>
          <p:cNvSpPr/>
          <p:nvPr/>
        </p:nvSpPr>
        <p:spPr>
          <a:xfrm>
            <a:off x="5013360" y="2619360"/>
            <a:ext cx="191880" cy="149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Box 14"/>
          <p:cNvSpPr/>
          <p:nvPr/>
        </p:nvSpPr>
        <p:spPr>
          <a:xfrm>
            <a:off x="4935600" y="2550960"/>
            <a:ext cx="503280" cy="27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ANXA1</a:t>
            </a:r>
            <a:br>
              <a:rPr sz="400"/>
            </a:br>
            <a:r>
              <a:rPr b="1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ANXA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66"/>
          <p:cNvSpPr/>
          <p:nvPr/>
        </p:nvSpPr>
        <p:spPr>
          <a:xfrm>
            <a:off x="843120" y="4218120"/>
            <a:ext cx="191880" cy="149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Box 14"/>
          <p:cNvSpPr/>
          <p:nvPr/>
        </p:nvSpPr>
        <p:spPr>
          <a:xfrm>
            <a:off x="765000" y="4151160"/>
            <a:ext cx="503280" cy="27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ANXA1</a:t>
            </a:r>
            <a:br>
              <a:rPr sz="400"/>
            </a:br>
            <a:r>
              <a:rPr b="1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ANXA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68"/>
          <p:cNvSpPr/>
          <p:nvPr/>
        </p:nvSpPr>
        <p:spPr>
          <a:xfrm>
            <a:off x="2892600" y="4218120"/>
            <a:ext cx="193680" cy="149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Box 14"/>
          <p:cNvSpPr/>
          <p:nvPr/>
        </p:nvSpPr>
        <p:spPr>
          <a:xfrm>
            <a:off x="2814480" y="4151160"/>
            <a:ext cx="505080" cy="27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ANXA1</a:t>
            </a:r>
            <a:br>
              <a:rPr sz="400"/>
            </a:br>
            <a:r>
              <a:rPr b="1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ANXA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70"/>
          <p:cNvSpPr/>
          <p:nvPr/>
        </p:nvSpPr>
        <p:spPr>
          <a:xfrm>
            <a:off x="5013360" y="4224240"/>
            <a:ext cx="191880" cy="149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Box 14"/>
          <p:cNvSpPr/>
          <p:nvPr/>
        </p:nvSpPr>
        <p:spPr>
          <a:xfrm>
            <a:off x="4935600" y="4157640"/>
            <a:ext cx="503280" cy="27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ANXA1</a:t>
            </a:r>
            <a:br>
              <a:rPr sz="400"/>
            </a:br>
            <a:r>
              <a:rPr b="1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ANXA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72"/>
          <p:cNvSpPr/>
          <p:nvPr/>
        </p:nvSpPr>
        <p:spPr>
          <a:xfrm>
            <a:off x="814320" y="5729400"/>
            <a:ext cx="192240" cy="149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Box 14"/>
          <p:cNvSpPr/>
          <p:nvPr/>
        </p:nvSpPr>
        <p:spPr>
          <a:xfrm>
            <a:off x="736560" y="5661000"/>
            <a:ext cx="503280" cy="27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ANXA1</a:t>
            </a:r>
            <a:br>
              <a:rPr sz="400"/>
            </a:br>
            <a:r>
              <a:rPr b="1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ANXA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Rectangle 74"/>
          <p:cNvSpPr/>
          <p:nvPr/>
        </p:nvSpPr>
        <p:spPr>
          <a:xfrm>
            <a:off x="2930400" y="5726160"/>
            <a:ext cx="193680" cy="149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Box 14"/>
          <p:cNvSpPr/>
          <p:nvPr/>
        </p:nvSpPr>
        <p:spPr>
          <a:xfrm>
            <a:off x="2847960" y="5657760"/>
            <a:ext cx="504720" cy="27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ANXA1</a:t>
            </a:r>
            <a:br>
              <a:rPr sz="400"/>
            </a:br>
            <a:r>
              <a:rPr b="1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ANXA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tangle 76"/>
          <p:cNvSpPr/>
          <p:nvPr/>
        </p:nvSpPr>
        <p:spPr>
          <a:xfrm>
            <a:off x="4995720" y="5729400"/>
            <a:ext cx="192240" cy="149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Box 14"/>
          <p:cNvSpPr/>
          <p:nvPr/>
        </p:nvSpPr>
        <p:spPr>
          <a:xfrm>
            <a:off x="4913280" y="5665680"/>
            <a:ext cx="503280" cy="27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ANXA1</a:t>
            </a:r>
            <a:br>
              <a:rPr sz="400"/>
            </a:br>
            <a:r>
              <a:rPr b="1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ANXA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02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1-01T11:57:37Z</dcterms:created>
  <dc:creator>Marcelo Sobral Leite</dc:creator>
  <dc:description/>
  <dc:language>en-US</dc:language>
  <cp:lastModifiedBy>Marcelo Sobral-Leite</cp:lastModifiedBy>
  <cp:lastPrinted>2014-09-08T08:30:29Z</cp:lastPrinted>
  <dcterms:modified xsi:type="dcterms:W3CDTF">2015-04-29T15:20:25Z</dcterms:modified>
  <cp:revision>413</cp:revision>
  <dc:subject/>
  <dc:title>Slide 1</dc:title>
</cp:coreProperties>
</file>